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62" r:id="rId2"/>
  </p:sldIdLst>
  <p:sldSz cx="6858000" cy="9144000" type="screen4x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015" autoAdjust="0"/>
    <p:restoredTop sz="80062"/>
  </p:normalViewPr>
  <p:slideViewPr>
    <p:cSldViewPr snapToGrid="0" snapToObjects="1">
      <p:cViewPr varScale="1">
        <p:scale>
          <a:sx n="85" d="100"/>
          <a:sy n="85" d="100"/>
        </p:scale>
        <p:origin x="-2724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020B4F-419C-914F-8D8C-068A43549A34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AA33D8-C132-3F44-82EC-6FC4CA8054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826100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9C4681-39C4-3B4D-9204-BD06B6CAA7B4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703638" y="857250"/>
            <a:ext cx="173672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BF9D42-348E-484A-8D7A-21D6BE5571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88031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3BF9D42-348E-484A-8D7A-21D6BE55715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22496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5408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7887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3034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09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6187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9859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6184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02605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4235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2913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9525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13201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Rectangle 1118">
            <a:extLst>
              <a:ext uri="{FF2B5EF4-FFF2-40B4-BE49-F238E27FC236}">
                <a16:creationId xmlns="" xmlns:a16="http://schemas.microsoft.com/office/drawing/2014/main" id="{7A82E91D-3186-44A8-B0E6-05119CD9E5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8887" y="4582649"/>
            <a:ext cx="377289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gradFill rotWithShape="1">
                  <a:gsLst>
                    <a:gs pos="0">
                      <a:srgbClr val="66FF66"/>
                    </a:gs>
                    <a:gs pos="100000">
                      <a:srgbClr val="009900"/>
                    </a:gs>
                  </a:gsLst>
                  <a:path path="shape">
                    <a:fillToRect l="50000" t="50000" r="50000" b="50000"/>
                  </a:path>
                </a:gra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5 Fig. Evaluation of the lifespan of </a:t>
            </a:r>
            <a:r>
              <a:rPr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altLang="ja-JP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egans</a:t>
            </a:r>
            <a:r>
              <a:rPr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Δfer-15.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Line 6">
            <a:extLst>
              <a:ext uri="{FF2B5EF4-FFF2-40B4-BE49-F238E27FC236}">
                <a16:creationId xmlns="" xmlns:a16="http://schemas.microsoft.com/office/drawing/2014/main" id="{09A83EC8-244A-4576-8BE9-7A1D458E4EE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288811" y="568820"/>
            <a:ext cx="0" cy="2505867"/>
          </a:xfrm>
          <a:prstGeom prst="line">
            <a:avLst/>
          </a:prstGeom>
          <a:noFill/>
          <a:ln w="6350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7" name="Freeform 7">
            <a:extLst>
              <a:ext uri="{FF2B5EF4-FFF2-40B4-BE49-F238E27FC236}">
                <a16:creationId xmlns="" xmlns:a16="http://schemas.microsoft.com/office/drawing/2014/main" id="{25E5C374-B286-41A7-B129-E30A70FC3914}"/>
              </a:ext>
            </a:extLst>
          </p:cNvPr>
          <p:cNvSpPr>
            <a:spLocks noEditPoints="1"/>
          </p:cNvSpPr>
          <p:nvPr/>
        </p:nvSpPr>
        <p:spPr bwMode="auto">
          <a:xfrm>
            <a:off x="1263337" y="797561"/>
            <a:ext cx="25474" cy="2277126"/>
          </a:xfrm>
          <a:custGeom>
            <a:avLst/>
            <a:gdLst>
              <a:gd name="T0" fmla="*/ 0 w 16"/>
              <a:gd name="T1" fmla="*/ 1772 h 1772"/>
              <a:gd name="T2" fmla="*/ 16 w 16"/>
              <a:gd name="T3" fmla="*/ 1772 h 1772"/>
              <a:gd name="T4" fmla="*/ 0 w 16"/>
              <a:gd name="T5" fmla="*/ 1420 h 1772"/>
              <a:gd name="T6" fmla="*/ 16 w 16"/>
              <a:gd name="T7" fmla="*/ 1420 h 1772"/>
              <a:gd name="T8" fmla="*/ 0 w 16"/>
              <a:gd name="T9" fmla="*/ 1064 h 1772"/>
              <a:gd name="T10" fmla="*/ 16 w 16"/>
              <a:gd name="T11" fmla="*/ 1064 h 1772"/>
              <a:gd name="T12" fmla="*/ 0 w 16"/>
              <a:gd name="T13" fmla="*/ 708 h 1772"/>
              <a:gd name="T14" fmla="*/ 16 w 16"/>
              <a:gd name="T15" fmla="*/ 708 h 1772"/>
              <a:gd name="T16" fmla="*/ 0 w 16"/>
              <a:gd name="T17" fmla="*/ 351 h 1772"/>
              <a:gd name="T18" fmla="*/ 16 w 16"/>
              <a:gd name="T19" fmla="*/ 351 h 1772"/>
              <a:gd name="T20" fmla="*/ 0 w 16"/>
              <a:gd name="T21" fmla="*/ 0 h 1772"/>
              <a:gd name="T22" fmla="*/ 16 w 16"/>
              <a:gd name="T23" fmla="*/ 0 h 17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16" h="1772">
                <a:moveTo>
                  <a:pt x="0" y="1772"/>
                </a:moveTo>
                <a:lnTo>
                  <a:pt x="16" y="1772"/>
                </a:lnTo>
                <a:moveTo>
                  <a:pt x="0" y="1420"/>
                </a:moveTo>
                <a:lnTo>
                  <a:pt x="16" y="1420"/>
                </a:lnTo>
                <a:moveTo>
                  <a:pt x="0" y="1064"/>
                </a:moveTo>
                <a:lnTo>
                  <a:pt x="16" y="1064"/>
                </a:lnTo>
                <a:moveTo>
                  <a:pt x="0" y="708"/>
                </a:moveTo>
                <a:lnTo>
                  <a:pt x="16" y="708"/>
                </a:lnTo>
                <a:moveTo>
                  <a:pt x="0" y="351"/>
                </a:moveTo>
                <a:lnTo>
                  <a:pt x="16" y="351"/>
                </a:lnTo>
                <a:moveTo>
                  <a:pt x="0" y="0"/>
                </a:moveTo>
                <a:lnTo>
                  <a:pt x="16" y="0"/>
                </a:lnTo>
              </a:path>
            </a:pathLst>
          </a:custGeom>
          <a:noFill/>
          <a:ln w="6350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8" name="Line 8">
            <a:extLst>
              <a:ext uri="{FF2B5EF4-FFF2-40B4-BE49-F238E27FC236}">
                <a16:creationId xmlns="" xmlns:a16="http://schemas.microsoft.com/office/drawing/2014/main" id="{BA6BC0F2-C4E6-4B00-B56F-506468AA0516}"/>
              </a:ext>
            </a:extLst>
          </p:cNvPr>
          <p:cNvSpPr>
            <a:spLocks noChangeShapeType="1"/>
          </p:cNvSpPr>
          <p:nvPr/>
        </p:nvSpPr>
        <p:spPr bwMode="auto">
          <a:xfrm>
            <a:off x="1288811" y="3074687"/>
            <a:ext cx="4932419" cy="0"/>
          </a:xfrm>
          <a:prstGeom prst="line">
            <a:avLst/>
          </a:prstGeom>
          <a:noFill/>
          <a:ln w="6350" cap="flat">
            <a:solidFill>
              <a:srgbClr val="89898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9" name="Freeform 9">
            <a:extLst>
              <a:ext uri="{FF2B5EF4-FFF2-40B4-BE49-F238E27FC236}">
                <a16:creationId xmlns="" xmlns:a16="http://schemas.microsoft.com/office/drawing/2014/main" id="{515A7980-BE80-4865-9C99-8B746EF993C7}"/>
              </a:ext>
            </a:extLst>
          </p:cNvPr>
          <p:cNvSpPr>
            <a:spLocks noEditPoints="1"/>
          </p:cNvSpPr>
          <p:nvPr/>
        </p:nvSpPr>
        <p:spPr bwMode="auto">
          <a:xfrm>
            <a:off x="1288811" y="3074687"/>
            <a:ext cx="4481847" cy="25701"/>
          </a:xfrm>
          <a:custGeom>
            <a:avLst/>
            <a:gdLst>
              <a:gd name="T0" fmla="*/ 0 w 2815"/>
              <a:gd name="T1" fmla="*/ 0 h 20"/>
              <a:gd name="T2" fmla="*/ 0 w 2815"/>
              <a:gd name="T3" fmla="*/ 20 h 20"/>
              <a:gd name="T4" fmla="*/ 707 w 2815"/>
              <a:gd name="T5" fmla="*/ 0 h 20"/>
              <a:gd name="T6" fmla="*/ 707 w 2815"/>
              <a:gd name="T7" fmla="*/ 20 h 20"/>
              <a:gd name="T8" fmla="*/ 1410 w 2815"/>
              <a:gd name="T9" fmla="*/ 0 h 20"/>
              <a:gd name="T10" fmla="*/ 1410 w 2815"/>
              <a:gd name="T11" fmla="*/ 20 h 20"/>
              <a:gd name="T12" fmla="*/ 2113 w 2815"/>
              <a:gd name="T13" fmla="*/ 0 h 20"/>
              <a:gd name="T14" fmla="*/ 2113 w 2815"/>
              <a:gd name="T15" fmla="*/ 20 h 20"/>
              <a:gd name="T16" fmla="*/ 2815 w 2815"/>
              <a:gd name="T17" fmla="*/ 0 h 20"/>
              <a:gd name="T18" fmla="*/ 2815 w 2815"/>
              <a:gd name="T19" fmla="*/ 20 h 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815" h="20">
                <a:moveTo>
                  <a:pt x="0" y="0"/>
                </a:moveTo>
                <a:lnTo>
                  <a:pt x="0" y="20"/>
                </a:lnTo>
                <a:moveTo>
                  <a:pt x="707" y="0"/>
                </a:moveTo>
                <a:lnTo>
                  <a:pt x="707" y="20"/>
                </a:lnTo>
                <a:moveTo>
                  <a:pt x="1410" y="0"/>
                </a:moveTo>
                <a:lnTo>
                  <a:pt x="1410" y="20"/>
                </a:lnTo>
                <a:moveTo>
                  <a:pt x="2113" y="0"/>
                </a:moveTo>
                <a:lnTo>
                  <a:pt x="2113" y="20"/>
                </a:lnTo>
                <a:moveTo>
                  <a:pt x="2815" y="0"/>
                </a:moveTo>
                <a:lnTo>
                  <a:pt x="2815" y="20"/>
                </a:lnTo>
              </a:path>
            </a:pathLst>
          </a:custGeom>
          <a:noFill/>
          <a:ln w="6350" cap="flat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0" name="Freeform 10">
            <a:extLst>
              <a:ext uri="{FF2B5EF4-FFF2-40B4-BE49-F238E27FC236}">
                <a16:creationId xmlns="" xmlns:a16="http://schemas.microsoft.com/office/drawing/2014/main" id="{1F68E575-A8D0-441F-AFE2-F2ADF83854CE}"/>
              </a:ext>
            </a:extLst>
          </p:cNvPr>
          <p:cNvSpPr>
            <a:spLocks/>
          </p:cNvSpPr>
          <p:nvPr/>
        </p:nvSpPr>
        <p:spPr bwMode="auto">
          <a:xfrm>
            <a:off x="1288811" y="797561"/>
            <a:ext cx="3588661" cy="2277126"/>
          </a:xfrm>
          <a:custGeom>
            <a:avLst/>
            <a:gdLst>
              <a:gd name="T0" fmla="*/ 0 w 2254"/>
              <a:gd name="T1" fmla="*/ 0 h 1772"/>
              <a:gd name="T2" fmla="*/ 849 w 2254"/>
              <a:gd name="T3" fmla="*/ 0 h 1772"/>
              <a:gd name="T4" fmla="*/ 849 w 2254"/>
              <a:gd name="T5" fmla="*/ 41 h 1772"/>
              <a:gd name="T6" fmla="*/ 1410 w 2254"/>
              <a:gd name="T7" fmla="*/ 41 h 1772"/>
              <a:gd name="T8" fmla="*/ 1410 w 2254"/>
              <a:gd name="T9" fmla="*/ 132 h 1772"/>
              <a:gd name="T10" fmla="*/ 1693 w 2254"/>
              <a:gd name="T11" fmla="*/ 132 h 1772"/>
              <a:gd name="T12" fmla="*/ 1693 w 2254"/>
              <a:gd name="T13" fmla="*/ 530 h 1772"/>
              <a:gd name="T14" fmla="*/ 1971 w 2254"/>
              <a:gd name="T15" fmla="*/ 530 h 1772"/>
              <a:gd name="T16" fmla="*/ 1971 w 2254"/>
              <a:gd name="T17" fmla="*/ 1420 h 1772"/>
              <a:gd name="T18" fmla="*/ 2254 w 2254"/>
              <a:gd name="T19" fmla="*/ 1420 h 1772"/>
              <a:gd name="T20" fmla="*/ 2254 w 2254"/>
              <a:gd name="T21" fmla="*/ 1772 h 17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</a:cxnLst>
            <a:rect l="0" t="0" r="r" b="b"/>
            <a:pathLst>
              <a:path w="2254" h="1772">
                <a:moveTo>
                  <a:pt x="0" y="0"/>
                </a:moveTo>
                <a:lnTo>
                  <a:pt x="849" y="0"/>
                </a:lnTo>
                <a:lnTo>
                  <a:pt x="849" y="41"/>
                </a:lnTo>
                <a:lnTo>
                  <a:pt x="1410" y="41"/>
                </a:lnTo>
                <a:lnTo>
                  <a:pt x="1410" y="132"/>
                </a:lnTo>
                <a:lnTo>
                  <a:pt x="1693" y="132"/>
                </a:lnTo>
                <a:lnTo>
                  <a:pt x="1693" y="530"/>
                </a:lnTo>
                <a:lnTo>
                  <a:pt x="1971" y="530"/>
                </a:lnTo>
                <a:lnTo>
                  <a:pt x="1971" y="1420"/>
                </a:lnTo>
                <a:lnTo>
                  <a:pt x="2254" y="1420"/>
                </a:lnTo>
                <a:lnTo>
                  <a:pt x="2254" y="1772"/>
                </a:lnTo>
              </a:path>
            </a:pathLst>
          </a:custGeom>
          <a:noFill/>
          <a:ln w="19050" cap="rnd">
            <a:solidFill>
              <a:srgbClr val="76717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1" name="Freeform 11">
            <a:extLst>
              <a:ext uri="{FF2B5EF4-FFF2-40B4-BE49-F238E27FC236}">
                <a16:creationId xmlns="" xmlns:a16="http://schemas.microsoft.com/office/drawing/2014/main" id="{355368D6-4DE4-4C19-849C-B50EDC94FEF9}"/>
              </a:ext>
            </a:extLst>
          </p:cNvPr>
          <p:cNvSpPr>
            <a:spLocks/>
          </p:cNvSpPr>
          <p:nvPr/>
        </p:nvSpPr>
        <p:spPr bwMode="auto">
          <a:xfrm>
            <a:off x="1288811" y="797561"/>
            <a:ext cx="3588661" cy="2277126"/>
          </a:xfrm>
          <a:custGeom>
            <a:avLst/>
            <a:gdLst>
              <a:gd name="T0" fmla="*/ 0 w 2254"/>
              <a:gd name="T1" fmla="*/ 0 h 1772"/>
              <a:gd name="T2" fmla="*/ 986 w 2254"/>
              <a:gd name="T3" fmla="*/ 0 h 1772"/>
              <a:gd name="T4" fmla="*/ 986 w 2254"/>
              <a:gd name="T5" fmla="*/ 182 h 1772"/>
              <a:gd name="T6" fmla="*/ 1693 w 2254"/>
              <a:gd name="T7" fmla="*/ 182 h 1772"/>
              <a:gd name="T8" fmla="*/ 1693 w 2254"/>
              <a:gd name="T9" fmla="*/ 592 h 1772"/>
              <a:gd name="T10" fmla="*/ 1971 w 2254"/>
              <a:gd name="T11" fmla="*/ 592 h 1772"/>
              <a:gd name="T12" fmla="*/ 1971 w 2254"/>
              <a:gd name="T13" fmla="*/ 1478 h 1772"/>
              <a:gd name="T14" fmla="*/ 2254 w 2254"/>
              <a:gd name="T15" fmla="*/ 1478 h 1772"/>
              <a:gd name="T16" fmla="*/ 2254 w 2254"/>
              <a:gd name="T17" fmla="*/ 1772 h 17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2254" h="1772">
                <a:moveTo>
                  <a:pt x="0" y="0"/>
                </a:moveTo>
                <a:lnTo>
                  <a:pt x="986" y="0"/>
                </a:lnTo>
                <a:lnTo>
                  <a:pt x="986" y="182"/>
                </a:lnTo>
                <a:lnTo>
                  <a:pt x="1693" y="182"/>
                </a:lnTo>
                <a:lnTo>
                  <a:pt x="1693" y="592"/>
                </a:lnTo>
                <a:lnTo>
                  <a:pt x="1971" y="592"/>
                </a:lnTo>
                <a:lnTo>
                  <a:pt x="1971" y="1478"/>
                </a:lnTo>
                <a:lnTo>
                  <a:pt x="2254" y="1478"/>
                </a:lnTo>
                <a:lnTo>
                  <a:pt x="2254" y="1772"/>
                </a:lnTo>
              </a:path>
            </a:pathLst>
          </a:custGeom>
          <a:noFill/>
          <a:ln w="19050" cap="rnd">
            <a:solidFill>
              <a:srgbClr val="00B05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2" name="Freeform 12">
            <a:extLst>
              <a:ext uri="{FF2B5EF4-FFF2-40B4-BE49-F238E27FC236}">
                <a16:creationId xmlns="" xmlns:a16="http://schemas.microsoft.com/office/drawing/2014/main" id="{7B318A93-95E8-4078-A786-645F1E21E2EA}"/>
              </a:ext>
            </a:extLst>
          </p:cNvPr>
          <p:cNvSpPr>
            <a:spLocks/>
          </p:cNvSpPr>
          <p:nvPr/>
        </p:nvSpPr>
        <p:spPr bwMode="auto">
          <a:xfrm>
            <a:off x="1288811" y="797561"/>
            <a:ext cx="3588661" cy="2277126"/>
          </a:xfrm>
          <a:custGeom>
            <a:avLst/>
            <a:gdLst>
              <a:gd name="T0" fmla="*/ 0 w 2254"/>
              <a:gd name="T1" fmla="*/ 0 h 1772"/>
              <a:gd name="T2" fmla="*/ 1127 w 2254"/>
              <a:gd name="T3" fmla="*/ 0 h 1772"/>
              <a:gd name="T4" fmla="*/ 1127 w 2254"/>
              <a:gd name="T5" fmla="*/ 33 h 1772"/>
              <a:gd name="T6" fmla="*/ 1269 w 2254"/>
              <a:gd name="T7" fmla="*/ 33 h 1772"/>
              <a:gd name="T8" fmla="*/ 1269 w 2254"/>
              <a:gd name="T9" fmla="*/ 70 h 1772"/>
              <a:gd name="T10" fmla="*/ 1410 w 2254"/>
              <a:gd name="T11" fmla="*/ 70 h 1772"/>
              <a:gd name="T12" fmla="*/ 1410 w 2254"/>
              <a:gd name="T13" fmla="*/ 215 h 1772"/>
              <a:gd name="T14" fmla="*/ 1693 w 2254"/>
              <a:gd name="T15" fmla="*/ 215 h 1772"/>
              <a:gd name="T16" fmla="*/ 1693 w 2254"/>
              <a:gd name="T17" fmla="*/ 612 h 1772"/>
              <a:gd name="T18" fmla="*/ 1971 w 2254"/>
              <a:gd name="T19" fmla="*/ 612 h 1772"/>
              <a:gd name="T20" fmla="*/ 1971 w 2254"/>
              <a:gd name="T21" fmla="*/ 1519 h 1772"/>
              <a:gd name="T22" fmla="*/ 2254 w 2254"/>
              <a:gd name="T23" fmla="*/ 1519 h 1772"/>
              <a:gd name="T24" fmla="*/ 2254 w 2254"/>
              <a:gd name="T25" fmla="*/ 1772 h 17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</a:cxnLst>
            <a:rect l="0" t="0" r="r" b="b"/>
            <a:pathLst>
              <a:path w="2254" h="1772">
                <a:moveTo>
                  <a:pt x="0" y="0"/>
                </a:moveTo>
                <a:lnTo>
                  <a:pt x="1127" y="0"/>
                </a:lnTo>
                <a:lnTo>
                  <a:pt x="1127" y="33"/>
                </a:lnTo>
                <a:lnTo>
                  <a:pt x="1269" y="33"/>
                </a:lnTo>
                <a:lnTo>
                  <a:pt x="1269" y="70"/>
                </a:lnTo>
                <a:lnTo>
                  <a:pt x="1410" y="70"/>
                </a:lnTo>
                <a:lnTo>
                  <a:pt x="1410" y="215"/>
                </a:lnTo>
                <a:lnTo>
                  <a:pt x="1693" y="215"/>
                </a:lnTo>
                <a:lnTo>
                  <a:pt x="1693" y="612"/>
                </a:lnTo>
                <a:lnTo>
                  <a:pt x="1971" y="612"/>
                </a:lnTo>
                <a:lnTo>
                  <a:pt x="1971" y="1519"/>
                </a:lnTo>
                <a:lnTo>
                  <a:pt x="2254" y="1519"/>
                </a:lnTo>
                <a:lnTo>
                  <a:pt x="2254" y="1772"/>
                </a:lnTo>
              </a:path>
            </a:pathLst>
          </a:custGeom>
          <a:noFill/>
          <a:ln w="19050" cap="rnd">
            <a:solidFill>
              <a:srgbClr val="4472C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3" name="Freeform 13">
            <a:extLst>
              <a:ext uri="{FF2B5EF4-FFF2-40B4-BE49-F238E27FC236}">
                <a16:creationId xmlns="" xmlns:a16="http://schemas.microsoft.com/office/drawing/2014/main" id="{1BDB2D40-72AC-4AA8-BE94-428AF31DF897}"/>
              </a:ext>
            </a:extLst>
          </p:cNvPr>
          <p:cNvSpPr>
            <a:spLocks/>
          </p:cNvSpPr>
          <p:nvPr/>
        </p:nvSpPr>
        <p:spPr bwMode="auto">
          <a:xfrm>
            <a:off x="1288811" y="797561"/>
            <a:ext cx="3813152" cy="2277126"/>
          </a:xfrm>
          <a:custGeom>
            <a:avLst/>
            <a:gdLst>
              <a:gd name="T0" fmla="*/ 0 w 2395"/>
              <a:gd name="T1" fmla="*/ 0 h 1772"/>
              <a:gd name="T2" fmla="*/ 1127 w 2395"/>
              <a:gd name="T3" fmla="*/ 0 h 1772"/>
              <a:gd name="T4" fmla="*/ 1127 w 2395"/>
              <a:gd name="T5" fmla="*/ 37 h 1772"/>
              <a:gd name="T6" fmla="*/ 1410 w 2395"/>
              <a:gd name="T7" fmla="*/ 37 h 1772"/>
              <a:gd name="T8" fmla="*/ 1410 w 2395"/>
              <a:gd name="T9" fmla="*/ 294 h 1772"/>
              <a:gd name="T10" fmla="*/ 1693 w 2395"/>
              <a:gd name="T11" fmla="*/ 294 h 1772"/>
              <a:gd name="T12" fmla="*/ 1693 w 2395"/>
              <a:gd name="T13" fmla="*/ 443 h 1772"/>
              <a:gd name="T14" fmla="*/ 1971 w 2395"/>
              <a:gd name="T15" fmla="*/ 443 h 1772"/>
              <a:gd name="T16" fmla="*/ 1971 w 2395"/>
              <a:gd name="T17" fmla="*/ 1254 h 1772"/>
              <a:gd name="T18" fmla="*/ 2254 w 2395"/>
              <a:gd name="T19" fmla="*/ 1254 h 1772"/>
              <a:gd name="T20" fmla="*/ 2254 w 2395"/>
              <a:gd name="T21" fmla="*/ 1734 h 1772"/>
              <a:gd name="T22" fmla="*/ 2395 w 2395"/>
              <a:gd name="T23" fmla="*/ 1734 h 1772"/>
              <a:gd name="T24" fmla="*/ 2395 w 2395"/>
              <a:gd name="T25" fmla="*/ 1772 h 17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</a:cxnLst>
            <a:rect l="0" t="0" r="r" b="b"/>
            <a:pathLst>
              <a:path w="2395" h="1772">
                <a:moveTo>
                  <a:pt x="0" y="0"/>
                </a:moveTo>
                <a:lnTo>
                  <a:pt x="1127" y="0"/>
                </a:lnTo>
                <a:lnTo>
                  <a:pt x="1127" y="37"/>
                </a:lnTo>
                <a:lnTo>
                  <a:pt x="1410" y="37"/>
                </a:lnTo>
                <a:lnTo>
                  <a:pt x="1410" y="294"/>
                </a:lnTo>
                <a:lnTo>
                  <a:pt x="1693" y="294"/>
                </a:lnTo>
                <a:lnTo>
                  <a:pt x="1693" y="443"/>
                </a:lnTo>
                <a:lnTo>
                  <a:pt x="1971" y="443"/>
                </a:lnTo>
                <a:lnTo>
                  <a:pt x="1971" y="1254"/>
                </a:lnTo>
                <a:lnTo>
                  <a:pt x="2254" y="1254"/>
                </a:lnTo>
                <a:lnTo>
                  <a:pt x="2254" y="1734"/>
                </a:lnTo>
                <a:lnTo>
                  <a:pt x="2395" y="1734"/>
                </a:lnTo>
                <a:lnTo>
                  <a:pt x="2395" y="1772"/>
                </a:lnTo>
              </a:path>
            </a:pathLst>
          </a:custGeom>
          <a:noFill/>
          <a:ln w="19050" cap="rnd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05" name="正方形/長方形 204">
            <a:extLst>
              <a:ext uri="{FF2B5EF4-FFF2-40B4-BE49-F238E27FC236}">
                <a16:creationId xmlns="" xmlns:a16="http://schemas.microsoft.com/office/drawing/2014/main" id="{668564FD-5E1F-4F62-9E28-ED902DCEC4A6}"/>
              </a:ext>
            </a:extLst>
          </p:cNvPr>
          <p:cNvSpPr/>
          <p:nvPr/>
        </p:nvSpPr>
        <p:spPr>
          <a:xfrm>
            <a:off x="1814270" y="3728539"/>
            <a:ext cx="84350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i="1" dirty="0">
                <a:latin typeface="Times New Roman" panose="02020603050405020304" pitchFamily="18" charset="0"/>
              </a:rPr>
              <a:t>E. coli</a:t>
            </a:r>
            <a:r>
              <a:rPr lang="en-US" altLang="ja-JP" sz="1000" dirty="0">
                <a:latin typeface="Times New Roman" panose="02020603050405020304" pitchFamily="18" charset="0"/>
              </a:rPr>
              <a:t> OP50</a:t>
            </a:r>
            <a:endParaRPr lang="ja-JP" altLang="en-US" sz="1000" dirty="0"/>
          </a:p>
        </p:txBody>
      </p:sp>
      <p:sp>
        <p:nvSpPr>
          <p:cNvPr id="206" name="正方形/長方形 205">
            <a:extLst>
              <a:ext uri="{FF2B5EF4-FFF2-40B4-BE49-F238E27FC236}">
                <a16:creationId xmlns="" xmlns:a16="http://schemas.microsoft.com/office/drawing/2014/main" id="{ECF55CD5-534F-42C6-A127-9F05DF61D832}"/>
              </a:ext>
            </a:extLst>
          </p:cNvPr>
          <p:cNvSpPr/>
          <p:nvPr/>
        </p:nvSpPr>
        <p:spPr>
          <a:xfrm>
            <a:off x="3776171" y="3718969"/>
            <a:ext cx="16369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i="1" dirty="0">
                <a:latin typeface="Times New Roman" panose="02020603050405020304" pitchFamily="18" charset="0"/>
              </a:rPr>
              <a:t>S. thermophilus</a:t>
            </a:r>
            <a:r>
              <a:rPr lang="en-US" altLang="ja-JP" sz="1000" dirty="0">
                <a:latin typeface="Times New Roman" panose="02020603050405020304" pitchFamily="18" charset="0"/>
              </a:rPr>
              <a:t> NRIC0256</a:t>
            </a:r>
            <a:r>
              <a:rPr lang="en-US" altLang="ja-JP" sz="1000" baseline="30000" dirty="0">
                <a:latin typeface="Times New Roman" panose="02020603050405020304" pitchFamily="18" charset="0"/>
              </a:rPr>
              <a:t>T</a:t>
            </a:r>
            <a:endParaRPr lang="ja-JP" altLang="en-US" sz="1000" dirty="0"/>
          </a:p>
        </p:txBody>
      </p:sp>
      <p:sp>
        <p:nvSpPr>
          <p:cNvPr id="207" name="正方形/長方形 206">
            <a:extLst>
              <a:ext uri="{FF2B5EF4-FFF2-40B4-BE49-F238E27FC236}">
                <a16:creationId xmlns="" xmlns:a16="http://schemas.microsoft.com/office/drawing/2014/main" id="{BCFB5975-C035-4538-9F74-66901A35D075}"/>
              </a:ext>
            </a:extLst>
          </p:cNvPr>
          <p:cNvSpPr/>
          <p:nvPr/>
        </p:nvSpPr>
        <p:spPr>
          <a:xfrm>
            <a:off x="3775906" y="4045819"/>
            <a:ext cx="119455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i="1" dirty="0">
                <a:latin typeface="Times New Roman" panose="02020603050405020304" pitchFamily="18" charset="0"/>
              </a:rPr>
              <a:t>P. pentosaceus</a:t>
            </a:r>
            <a:r>
              <a:rPr lang="en-US" altLang="ja-JP" sz="1000" dirty="0">
                <a:latin typeface="Times New Roman" panose="02020603050405020304" pitchFamily="18" charset="0"/>
              </a:rPr>
              <a:t> Be1</a:t>
            </a:r>
            <a:endParaRPr lang="ja-JP" altLang="en-US" sz="1000" dirty="0"/>
          </a:p>
        </p:txBody>
      </p:sp>
      <p:sp>
        <p:nvSpPr>
          <p:cNvPr id="208" name="正方形/長方形 207">
            <a:extLst>
              <a:ext uri="{FF2B5EF4-FFF2-40B4-BE49-F238E27FC236}">
                <a16:creationId xmlns="" xmlns:a16="http://schemas.microsoft.com/office/drawing/2014/main" id="{81AC8AD9-C093-47A0-9A18-2B016DE9BEC2}"/>
              </a:ext>
            </a:extLst>
          </p:cNvPr>
          <p:cNvSpPr/>
          <p:nvPr/>
        </p:nvSpPr>
        <p:spPr>
          <a:xfrm>
            <a:off x="1814193" y="4053224"/>
            <a:ext cx="112723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i="1" dirty="0">
                <a:latin typeface="Times New Roman" panose="02020603050405020304" pitchFamily="18" charset="0"/>
              </a:rPr>
              <a:t>L. plantarum</a:t>
            </a:r>
            <a:r>
              <a:rPr lang="en-US" altLang="ja-JP" sz="1000" dirty="0">
                <a:latin typeface="Times New Roman" panose="02020603050405020304" pitchFamily="18" charset="0"/>
              </a:rPr>
              <a:t> P1-2</a:t>
            </a:r>
            <a:endParaRPr lang="ja-JP" altLang="en-US" sz="1000" dirty="0"/>
          </a:p>
        </p:txBody>
      </p:sp>
      <p:sp>
        <p:nvSpPr>
          <p:cNvPr id="209" name="Rectangle 13">
            <a:extLst>
              <a:ext uri="{FF2B5EF4-FFF2-40B4-BE49-F238E27FC236}">
                <a16:creationId xmlns="" xmlns:a16="http://schemas.microsoft.com/office/drawing/2014/main" id="{33935CC2-C411-4358-840D-16DF5D9533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6699" y="2996913"/>
            <a:ext cx="65579" cy="1573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0" name="Rectangle 14">
            <a:extLst>
              <a:ext uri="{FF2B5EF4-FFF2-40B4-BE49-F238E27FC236}">
                <a16:creationId xmlns="" xmlns:a16="http://schemas.microsoft.com/office/drawing/2014/main" id="{BB276428-DFC3-4AAB-BEA2-332C3C3BAE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91755" y="2540494"/>
            <a:ext cx="131158" cy="1573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1" name="Rectangle 15">
            <a:extLst>
              <a:ext uri="{FF2B5EF4-FFF2-40B4-BE49-F238E27FC236}">
                <a16:creationId xmlns="" xmlns:a16="http://schemas.microsoft.com/office/drawing/2014/main" id="{C8861660-D9DB-4837-B90F-99FCE5803A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91755" y="2089488"/>
            <a:ext cx="131158" cy="1573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" name="Rectangle 16">
            <a:extLst>
              <a:ext uri="{FF2B5EF4-FFF2-40B4-BE49-F238E27FC236}">
                <a16:creationId xmlns="" xmlns:a16="http://schemas.microsoft.com/office/drawing/2014/main" id="{55345AE3-AD05-4E0C-8866-DF7BE34876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91755" y="1634873"/>
            <a:ext cx="131158" cy="1573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" name="Rectangle 17">
            <a:extLst>
              <a:ext uri="{FF2B5EF4-FFF2-40B4-BE49-F238E27FC236}">
                <a16:creationId xmlns="" xmlns:a16="http://schemas.microsoft.com/office/drawing/2014/main" id="{F9AC0C38-E429-43A4-B815-ED339766C5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91755" y="1180259"/>
            <a:ext cx="131158" cy="1573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" name="Rectangle 18">
            <a:extLst>
              <a:ext uri="{FF2B5EF4-FFF2-40B4-BE49-F238E27FC236}">
                <a16:creationId xmlns="" xmlns:a16="http://schemas.microsoft.com/office/drawing/2014/main" id="{EE21DFA7-790D-4BA3-900A-FA24C8916E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26810" y="725644"/>
            <a:ext cx="196737" cy="1573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" name="Rectangle 19">
            <a:extLst>
              <a:ext uri="{FF2B5EF4-FFF2-40B4-BE49-F238E27FC236}">
                <a16:creationId xmlns="" xmlns:a16="http://schemas.microsoft.com/office/drawing/2014/main" id="{2F9E1427-33FE-4081-B53D-9C8898A93E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50222" y="3124855"/>
            <a:ext cx="64945" cy="1569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" name="Rectangle 20">
            <a:extLst>
              <a:ext uri="{FF2B5EF4-FFF2-40B4-BE49-F238E27FC236}">
                <a16:creationId xmlns="" xmlns:a16="http://schemas.microsoft.com/office/drawing/2014/main" id="{B9AA8061-7DBC-4A18-A8EA-512179CF07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4953" y="3124855"/>
            <a:ext cx="64945" cy="1569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7" name="Rectangle 21">
            <a:extLst>
              <a:ext uri="{FF2B5EF4-FFF2-40B4-BE49-F238E27FC236}">
                <a16:creationId xmlns="" xmlns:a16="http://schemas.microsoft.com/office/drawing/2014/main" id="{AFCC0225-87F5-4B31-8118-5EB400B4AF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87214" y="3124855"/>
            <a:ext cx="131694" cy="1569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8" name="Rectangle 22">
            <a:extLst>
              <a:ext uri="{FF2B5EF4-FFF2-40B4-BE49-F238E27FC236}">
                <a16:creationId xmlns="" xmlns:a16="http://schemas.microsoft.com/office/drawing/2014/main" id="{8780A5D9-4816-4A4E-A742-F587C5EC19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23750" y="3124855"/>
            <a:ext cx="131694" cy="1569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9" name="Rectangle 23">
            <a:extLst>
              <a:ext uri="{FF2B5EF4-FFF2-40B4-BE49-F238E27FC236}">
                <a16:creationId xmlns="" xmlns:a16="http://schemas.microsoft.com/office/drawing/2014/main" id="{80B27FB5-E086-45B2-A8AF-885C967C13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58482" y="3124855"/>
            <a:ext cx="131694" cy="1569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0" name="Rectangle 24">
            <a:extLst>
              <a:ext uri="{FF2B5EF4-FFF2-40B4-BE49-F238E27FC236}">
                <a16:creationId xmlns="" xmlns:a16="http://schemas.microsoft.com/office/drawing/2014/main" id="{1CF0A45A-998F-41A3-8E22-3309E96F40C6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498192" y="2013446"/>
            <a:ext cx="89607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ercent survival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1" name="Rectangle 25">
            <a:extLst>
              <a:ext uri="{FF2B5EF4-FFF2-40B4-BE49-F238E27FC236}">
                <a16:creationId xmlns="" xmlns:a16="http://schemas.microsoft.com/office/drawing/2014/main" id="{2C640F6D-1638-4B63-A77D-642A2F6FFC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10751" y="3336070"/>
            <a:ext cx="1242975" cy="1569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ays of after hatching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2" name="Line 26">
            <a:extLst>
              <a:ext uri="{FF2B5EF4-FFF2-40B4-BE49-F238E27FC236}">
                <a16:creationId xmlns="" xmlns:a16="http://schemas.microsoft.com/office/drawing/2014/main" id="{E40BD1CB-3381-407D-8868-6D67E5DDF8E2}"/>
              </a:ext>
            </a:extLst>
          </p:cNvPr>
          <p:cNvSpPr>
            <a:spLocks noChangeShapeType="1"/>
          </p:cNvSpPr>
          <p:nvPr/>
        </p:nvSpPr>
        <p:spPr bwMode="auto">
          <a:xfrm>
            <a:off x="1524000" y="3866083"/>
            <a:ext cx="244475" cy="0"/>
          </a:xfrm>
          <a:prstGeom prst="line">
            <a:avLst/>
          </a:prstGeom>
          <a:noFill/>
          <a:ln w="22225" cap="rnd">
            <a:solidFill>
              <a:srgbClr val="76717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3" name="Line 28">
            <a:extLst>
              <a:ext uri="{FF2B5EF4-FFF2-40B4-BE49-F238E27FC236}">
                <a16:creationId xmlns="" xmlns:a16="http://schemas.microsoft.com/office/drawing/2014/main" id="{4AA4F362-E65D-436D-A6FE-C13B3526C0A5}"/>
              </a:ext>
            </a:extLst>
          </p:cNvPr>
          <p:cNvSpPr>
            <a:spLocks noChangeShapeType="1"/>
          </p:cNvSpPr>
          <p:nvPr/>
        </p:nvSpPr>
        <p:spPr bwMode="auto">
          <a:xfrm>
            <a:off x="3541712" y="3866083"/>
            <a:ext cx="244475" cy="0"/>
          </a:xfrm>
          <a:prstGeom prst="line">
            <a:avLst/>
          </a:prstGeom>
          <a:noFill/>
          <a:ln w="22225" cap="rnd">
            <a:solidFill>
              <a:srgbClr val="00B05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4" name="Line 30">
            <a:extLst>
              <a:ext uri="{FF2B5EF4-FFF2-40B4-BE49-F238E27FC236}">
                <a16:creationId xmlns="" xmlns:a16="http://schemas.microsoft.com/office/drawing/2014/main" id="{B07180CA-47F6-41C8-9C52-1B7F600B9659}"/>
              </a:ext>
            </a:extLst>
          </p:cNvPr>
          <p:cNvSpPr>
            <a:spLocks noChangeShapeType="1"/>
          </p:cNvSpPr>
          <p:nvPr/>
        </p:nvSpPr>
        <p:spPr bwMode="auto">
          <a:xfrm>
            <a:off x="1524000" y="4183583"/>
            <a:ext cx="244475" cy="0"/>
          </a:xfrm>
          <a:prstGeom prst="line">
            <a:avLst/>
          </a:prstGeom>
          <a:noFill/>
          <a:ln w="22225" cap="rnd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5" name="Line 32">
            <a:extLst>
              <a:ext uri="{FF2B5EF4-FFF2-40B4-BE49-F238E27FC236}">
                <a16:creationId xmlns="" xmlns:a16="http://schemas.microsoft.com/office/drawing/2014/main" id="{F5A787CB-7E74-4CCD-9486-9A4DD007E6D3}"/>
              </a:ext>
            </a:extLst>
          </p:cNvPr>
          <p:cNvSpPr>
            <a:spLocks noChangeShapeType="1"/>
          </p:cNvSpPr>
          <p:nvPr/>
        </p:nvSpPr>
        <p:spPr bwMode="auto">
          <a:xfrm>
            <a:off x="3541712" y="4183583"/>
            <a:ext cx="244475" cy="0"/>
          </a:xfrm>
          <a:prstGeom prst="line">
            <a:avLst/>
          </a:prstGeom>
          <a:noFill/>
          <a:ln w="22225" cap="rnd">
            <a:solidFill>
              <a:srgbClr val="007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48773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solidFill>
          <a:srgbClr val="7F7F7F"/>
        </a:solidFill>
        <a:ln w="1588" cap="flat">
          <a:solidFill>
            <a:srgbClr val="7F7F7F"/>
          </a:solidFill>
          <a:prstDash val="solid"/>
          <a:bevel/>
          <a:headEnd/>
          <a:tailEnd/>
        </a:ln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algn="l">
          <a:defRPr sz="1000"/>
        </a:defPPr>
      </a:lstStyle>
    </a:spDef>
  </a:objectDefaults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3</TotalTime>
  <Words>47</Words>
  <Application>Microsoft Office PowerPoint</Application>
  <PresentationFormat>On-screen Show (4:3)</PresentationFormat>
  <Paragraphs>1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s200588</dc:creator>
  <cp:lastModifiedBy>Arshad Rezwan</cp:lastModifiedBy>
  <cp:revision>67</cp:revision>
  <cp:lastPrinted>2019-06-09T14:07:56Z</cp:lastPrinted>
  <dcterms:created xsi:type="dcterms:W3CDTF">2019-02-21T04:56:07Z</dcterms:created>
  <dcterms:modified xsi:type="dcterms:W3CDTF">2020-02-14T11:14:02Z</dcterms:modified>
</cp:coreProperties>
</file>